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B0000"/>
    <a:srgbClr val="AA0000"/>
    <a:srgbClr val="8E0000"/>
    <a:srgbClr val="710000"/>
    <a:srgbClr val="550000"/>
    <a:srgbClr val="390000"/>
    <a:srgbClr val="000000"/>
    <a:srgbClr val="1D0000"/>
    <a:srgbClr val="470000"/>
    <a:srgbClr val="63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7658" autoAdjust="0"/>
    <p:restoredTop sz="94660"/>
  </p:normalViewPr>
  <p:slideViewPr>
    <p:cSldViewPr snapToGrid="0">
      <p:cViewPr>
        <p:scale>
          <a:sx n="110" d="100"/>
          <a:sy n="110" d="100"/>
        </p:scale>
        <p:origin x="78" y="-15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69484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9097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652550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2440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2879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458590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8833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4380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2145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34644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726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0A002-9231-4873-B80D-7DA697758235}" type="datetimeFigureOut">
              <a:rPr kumimoji="1" lang="ja-JP" altLang="en-US" smtClean="0"/>
              <a:t>2017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132A68-76FC-4D83-9A97-F321CABF5D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36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図 27">
            <a:extLst>
              <a:ext uri="{FF2B5EF4-FFF2-40B4-BE49-F238E27FC236}">
                <a16:creationId xmlns:a16="http://schemas.microsoft.com/office/drawing/2014/main" id="{2CC838C9-8B49-48B8-8616-190CDBDC9B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6570000"/>
            <a:ext cx="2952750" cy="295275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000" y="3489234"/>
            <a:ext cx="4286250" cy="28575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88000" y="180000"/>
            <a:ext cx="2952750" cy="295275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2000" y="180000"/>
            <a:ext cx="2952750" cy="2952750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36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36000" y="3312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420000" y="3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 rot="-5400000">
            <a:off x="-1080000" y="1462918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 rot="-5400000">
            <a:off x="2332800" y="1462919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4856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1008000" y="31680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umber of replicates (</a:t>
            </a: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36000" y="6426000"/>
            <a:ext cx="6974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d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右中かっこ 1"/>
          <p:cNvSpPr/>
          <p:nvPr/>
        </p:nvSpPr>
        <p:spPr>
          <a:xfrm rot="5400000">
            <a:off x="3744000" y="5651693"/>
            <a:ext cx="90000" cy="1170000"/>
          </a:xfrm>
          <a:prstGeom prst="rightBrace">
            <a:avLst>
              <a:gd name="adj1" fmla="val 3141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9" name="右中かっこ 18"/>
          <p:cNvSpPr/>
          <p:nvPr/>
        </p:nvSpPr>
        <p:spPr>
          <a:xfrm rot="5400000">
            <a:off x="2800233" y="6036525"/>
            <a:ext cx="90000" cy="648000"/>
          </a:xfrm>
          <a:prstGeom prst="rightBrace">
            <a:avLst>
              <a:gd name="adj1" fmla="val 3141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0" name="右中かっこ 19"/>
          <p:cNvSpPr/>
          <p:nvPr/>
        </p:nvSpPr>
        <p:spPr>
          <a:xfrm rot="5400000">
            <a:off x="1845000" y="5199525"/>
            <a:ext cx="90000" cy="486000"/>
          </a:xfrm>
          <a:prstGeom prst="rightBrace">
            <a:avLst>
              <a:gd name="adj1" fmla="val 3141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右中かっこ 20"/>
          <p:cNvSpPr/>
          <p:nvPr/>
        </p:nvSpPr>
        <p:spPr>
          <a:xfrm rot="5400000">
            <a:off x="1059138" y="5328080"/>
            <a:ext cx="90000" cy="648000"/>
          </a:xfrm>
          <a:prstGeom prst="rightBrace">
            <a:avLst>
              <a:gd name="adj1" fmla="val 3141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685964" y="5753180"/>
            <a:ext cx="866611" cy="220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1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1451630" y="5538864"/>
            <a:ext cx="876302" cy="2248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8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385082" y="6448872"/>
            <a:ext cx="914170" cy="220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2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3314992" y="6363143"/>
            <a:ext cx="963757" cy="2205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ts val="1000"/>
              </a:lnSpc>
            </a:pPr>
            <a:r>
              <a:rPr kumimoji="1"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4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EEE9D5E-58C5-4B7C-A508-693D3C39D686}"/>
              </a:ext>
            </a:extLst>
          </p:cNvPr>
          <p:cNvSpPr txBox="1"/>
          <p:nvPr/>
        </p:nvSpPr>
        <p:spPr>
          <a:xfrm rot="-5400000">
            <a:off x="-1080000" y="7853687"/>
            <a:ext cx="2675751" cy="261610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centage of DEGs with 10% FDR (</a:t>
            </a:r>
            <a:r>
              <a:rPr lang="en-US" altLang="ja-JP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G</a:t>
            </a:r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5E099EB-AB7A-44ED-A208-EE222F3DC811}"/>
              </a:ext>
            </a:extLst>
          </p:cNvPr>
          <p:cNvSpPr txBox="1"/>
          <p:nvPr/>
        </p:nvSpPr>
        <p:spPr>
          <a:xfrm>
            <a:off x="1008000" y="9622800"/>
            <a:ext cx="20383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silhouette (AS)</a:t>
            </a:r>
            <a:endParaRPr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9608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 rtlCol="0" anchor="ctr"/>
      <a:lstStyle>
        <a:defPPr algn="ctr">
          <a:defRPr kumimoji="1"/>
        </a:defPPr>
      </a:lstStyle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07</TotalTime>
  <Words>62</Words>
  <Application>Microsoft Office PowerPoint</Application>
  <PresentationFormat>A4 210 x 297 mm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門田幸二</dc:creator>
  <cp:lastModifiedBy>門田幸二</cp:lastModifiedBy>
  <cp:revision>123</cp:revision>
  <dcterms:created xsi:type="dcterms:W3CDTF">2015-02-09T07:01:03Z</dcterms:created>
  <dcterms:modified xsi:type="dcterms:W3CDTF">2017-09-02T03:19:24Z</dcterms:modified>
</cp:coreProperties>
</file>